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101774" y="210935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5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Ultrasound fetal measurements at 28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" name="Tableau 6"/>
          <p:cNvGraphicFramePr>
            <a:graphicFrameLocks noGrp="1"/>
          </p:cNvGraphicFramePr>
          <p:nvPr/>
        </p:nvGraphicFramePr>
        <p:xfrm>
          <a:off x="101774" y="487950"/>
          <a:ext cx="6660000" cy="2509002"/>
        </p:xfrm>
        <a:graphic>
          <a:graphicData uri="http://schemas.openxmlformats.org/drawingml/2006/table">
            <a:tbl>
              <a:tblPr/>
              <a:tblGrid>
                <a:gridCol w="593696"/>
                <a:gridCol w="1368152"/>
                <a:gridCol w="288032"/>
                <a:gridCol w="288032"/>
                <a:gridCol w="1152128"/>
                <a:gridCol w="1152128"/>
                <a:gridCol w="432048"/>
                <a:gridCol w="1008112"/>
                <a:gridCol w="377672"/>
              </a:tblGrid>
              <a:tr h="250114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riable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umbe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of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etuses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dian</a:t>
                      </a:r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[Q1; Q3]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fr-FR" sz="8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am - </a:t>
                      </a:r>
                      <a:r>
                        <a:rPr lang="fr-FR" sz="1000" b="1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djusted</a:t>
                      </a:r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1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near</a:t>
                      </a:r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model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22007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β 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lue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I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-value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007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Umbilical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ulse (beat/min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4.0 [96.50; 145.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8.00 [70.75; 137.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7.27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63.095;28.538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47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sistance index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830 [0.773; 0.84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850 [0.748; 0.863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00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071;0.053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78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ulsatility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index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200 [1.570; 2.42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915 [1.773; 2.41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08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477;0.303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67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ystolic velocity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.42 [16.11; 24.44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82 [10.63; 22.03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2.761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10.271;4.75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48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stol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elocity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610 [2.700; 4.79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210 [2.650; 3.838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39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1.304;0.506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408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yst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/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st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elocity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ratio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140 [4.250; 6.42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345 [4.083; 6.61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111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1.935;1.713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90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007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erebral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ulse (beat/min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4.0 [86.50; 161.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3.00 [71.75; 116.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26.784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75.337;21.769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0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sistance index</a:t>
                      </a:r>
                    </a:p>
                  </a:txBody>
                  <a:tcPr marL="8965" marR="8965" marT="504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620 [0.555; 0.668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605 [0.555; 0.64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003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067;0.062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93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ulsatility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index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010 [0.895; 1.178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040 [0.930; 1.11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01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158;0.189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864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ystol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elocity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970 [6.113; 9.698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045 [5.548; 10.73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352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1.848;4.553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427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stolic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elocity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20 [2.453; 3.063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150 [2.280; 4.155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611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908;2.13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44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00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yst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/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st</a:t>
                      </a:r>
                      <a:r>
                        <a:rPr lang="fr-FR" sz="1000" b="0" i="0" u="none" strike="noStrike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elocity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tio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640 [2.275; 2.743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500 [2.295; 2.79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003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389;0.383]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989</a:t>
                      </a:r>
                    </a:p>
                  </a:txBody>
                  <a:tcPr marL="8965" marR="8965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101774" y="2997697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All data are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express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edian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[Q1;Q3]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2</TotalTime>
  <Words>309</Words>
  <Application>Microsoft Office PowerPoint</Application>
  <PresentationFormat>Affichage à l'écran (4:3)</PresentationFormat>
  <Paragraphs>11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45</cp:revision>
  <dcterms:created xsi:type="dcterms:W3CDTF">2015-02-24T15:36:47Z</dcterms:created>
  <dcterms:modified xsi:type="dcterms:W3CDTF">2016-02-08T10:30:00Z</dcterms:modified>
</cp:coreProperties>
</file>